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media/image1.wmf" ContentType="image/x-wmf"/>
  <Override PartName="/ppt/media/image2.png" ContentType="image/png"/>
  <Override PartName="/ppt/media/image3.jpeg" ContentType="image/jpeg"/>
  <Override PartName="/ppt/media/image4.png" ContentType="image/png"/>
  <Override PartName="/ppt/media/image5.png" ContentType="image/png"/>
  <Override PartName="/ppt/media/image6.jpeg" ContentType="image/jpeg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6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9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40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41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42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43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9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4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image" Target="../media/image1.wmf"/><Relationship Id="rId3" Type="http://schemas.openxmlformats.org/officeDocument/2006/relationships/image" Target="../media/image2.png"/><Relationship Id="rId4" Type="http://schemas.openxmlformats.org/officeDocument/2006/relationships/image" Target="../media/image3.jpe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jpeg"/><Relationship Id="rId8" Type="http://schemas.openxmlformats.org/officeDocument/2006/relationships/slideLayout" Target="../slideLayouts/slideLayout1.xml"/><Relationship Id="rId9" Type="http://schemas.openxmlformats.org/officeDocument/2006/relationships/slideLayout" Target="../slideLayouts/slideLayout2.xml"/><Relationship Id="rId10" Type="http://schemas.openxmlformats.org/officeDocument/2006/relationships/slideLayout" Target="../slideLayouts/slideLayout3.xml"/><Relationship Id="rId11" Type="http://schemas.openxmlformats.org/officeDocument/2006/relationships/slideLayout" Target="../slideLayouts/slideLayout4.xml"/><Relationship Id="rId12" Type="http://schemas.openxmlformats.org/officeDocument/2006/relationships/slideLayout" Target="../slideLayouts/slideLayout5.xml"/><Relationship Id="rId13" Type="http://schemas.openxmlformats.org/officeDocument/2006/relationships/slideLayout" Target="../slideLayouts/slideLayout6.xml"/><Relationship Id="rId14" Type="http://schemas.openxmlformats.org/officeDocument/2006/relationships/slideLayout" Target="../slideLayouts/slideLayout7.xml"/><Relationship Id="rId15" Type="http://schemas.openxmlformats.org/officeDocument/2006/relationships/slideLayout" Target="../slideLayouts/slideLayout8.xml"/><Relationship Id="rId16" Type="http://schemas.openxmlformats.org/officeDocument/2006/relationships/slideLayout" Target="../slideLayouts/slideLayout9.xml"/><Relationship Id="rId17" Type="http://schemas.openxmlformats.org/officeDocument/2006/relationships/slideLayout" Target="../slideLayouts/slideLayout10.xml"/><Relationship Id="rId18" Type="http://schemas.openxmlformats.org/officeDocument/2006/relationships/slideLayout" Target="../slideLayouts/slideLayout11.xml"/><Relationship Id="rId19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333399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33339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333399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333399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333399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333399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333399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333399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333399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333399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pic>
        <p:nvPicPr>
          <p:cNvPr id="2" name="" descr=""/>
          <p:cNvPicPr/>
          <p:nvPr/>
        </p:nvPicPr>
        <p:blipFill>
          <a:blip r:embed="rId2"/>
          <a:stretch/>
        </p:blipFill>
        <p:spPr>
          <a:xfrm>
            <a:off x="8751960" y="6324480"/>
            <a:ext cx="392040" cy="533520"/>
          </a:xfrm>
          <a:prstGeom prst="rect">
            <a:avLst/>
          </a:prstGeom>
          <a:ln w="0">
            <a:noFill/>
          </a:ln>
        </p:spPr>
      </p:pic>
      <p:pic>
        <p:nvPicPr>
          <p:cNvPr id="3" name="" descr=""/>
          <p:cNvPicPr/>
          <p:nvPr/>
        </p:nvPicPr>
        <p:blipFill>
          <a:blip r:embed="rId3">
            <a:alphaModFix amt="0"/>
          </a:blip>
          <a:stretch/>
        </p:blipFill>
        <p:spPr>
          <a:xfrm>
            <a:off x="7467480" y="6486480"/>
            <a:ext cx="1219320" cy="219240"/>
          </a:xfrm>
          <a:prstGeom prst="rect">
            <a:avLst/>
          </a:prstGeom>
          <a:ln w="0">
            <a:noFill/>
          </a:ln>
        </p:spPr>
      </p:pic>
      <p:pic>
        <p:nvPicPr>
          <p:cNvPr id="4" name="" descr=""/>
          <p:cNvPicPr/>
          <p:nvPr/>
        </p:nvPicPr>
        <p:blipFill>
          <a:blip r:embed="rId4"/>
          <a:stretch/>
        </p:blipFill>
        <p:spPr>
          <a:xfrm>
            <a:off x="533520" y="6400800"/>
            <a:ext cx="368280" cy="457200"/>
          </a:xfrm>
          <a:prstGeom prst="rect">
            <a:avLst/>
          </a:prstGeom>
          <a:ln w="0">
            <a:noFill/>
          </a:ln>
        </p:spPr>
      </p:pic>
      <p:pic>
        <p:nvPicPr>
          <p:cNvPr id="5" name="" descr=""/>
          <p:cNvPicPr/>
          <p:nvPr/>
        </p:nvPicPr>
        <p:blipFill>
          <a:blip r:embed="rId5"/>
          <a:stretch/>
        </p:blipFill>
        <p:spPr>
          <a:xfrm>
            <a:off x="990720" y="6400800"/>
            <a:ext cx="1904760" cy="398520"/>
          </a:xfrm>
          <a:prstGeom prst="rect">
            <a:avLst/>
          </a:prstGeom>
          <a:ln w="0">
            <a:noFill/>
          </a:ln>
        </p:spPr>
      </p:pic>
      <p:pic>
        <p:nvPicPr>
          <p:cNvPr id="6" name="" descr=""/>
          <p:cNvPicPr/>
          <p:nvPr/>
        </p:nvPicPr>
        <p:blipFill>
          <a:blip r:embed="rId6"/>
          <a:stretch/>
        </p:blipFill>
        <p:spPr>
          <a:xfrm>
            <a:off x="65160" y="6400800"/>
            <a:ext cx="392040" cy="442800"/>
          </a:xfrm>
          <a:prstGeom prst="rect">
            <a:avLst/>
          </a:prstGeom>
          <a:ln w="0">
            <a:noFill/>
          </a:ln>
        </p:spPr>
      </p:pic>
      <p:pic>
        <p:nvPicPr>
          <p:cNvPr id="7" name="" descr=""/>
          <p:cNvPicPr/>
          <p:nvPr/>
        </p:nvPicPr>
        <p:blipFill>
          <a:blip r:embed="rId7"/>
          <a:stretch/>
        </p:blipFill>
        <p:spPr>
          <a:xfrm>
            <a:off x="6172200" y="6481800"/>
            <a:ext cx="1219320" cy="223920"/>
          </a:xfrm>
          <a:prstGeom prst="rect">
            <a:avLst/>
          </a:prstGeom>
          <a:ln w="0">
            <a:noFill/>
          </a:ln>
        </p:spPr>
      </p:pic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8"/>
    <p:sldLayoutId id="2147483650" r:id="rId9"/>
    <p:sldLayoutId id="2147483651" r:id="rId10"/>
    <p:sldLayoutId id="2147483652" r:id="rId11"/>
    <p:sldLayoutId id="2147483653" r:id="rId12"/>
    <p:sldLayoutId id="2147483654" r:id="rId13"/>
    <p:sldLayoutId id="2147483655" r:id="rId14"/>
    <p:sldLayoutId id="2147483656" r:id="rId15"/>
    <p:sldLayoutId id="2147483657" r:id="rId16"/>
    <p:sldLayoutId id="2147483658" r:id="rId17"/>
    <p:sldLayoutId id="2147483659" r:id="rId18"/>
    <p:sldLayoutId id="2147483660" r:id="rId19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showMasterSp="0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"/>
          <p:cNvSpPr/>
          <p:nvPr/>
        </p:nvSpPr>
        <p:spPr>
          <a:xfrm>
            <a:off x="990720" y="1905120"/>
            <a:ext cx="3276360" cy="2971800"/>
          </a:xfrm>
          <a:prstGeom prst="ellipse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2590920" y="1828800"/>
            <a:ext cx="0" cy="297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447920" y="2590920"/>
            <a:ext cx="1066680" cy="165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Vac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f</a:t>
            </a:r>
            <a:r>
              <a:rPr b="0" lang="en-US" sz="2400" spc="-1" strike="noStrike" baseline="-25000">
                <a:solidFill>
                  <a:srgbClr val="000000"/>
                </a:solidFill>
                <a:latin typeface="Times New Roman"/>
              </a:rPr>
              <a:t>1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r</a:t>
            </a:r>
            <a:r>
              <a:rPr b="0" lang="en-US" sz="2400" spc="-1" strike="noStrike" baseline="-25000">
                <a:solidFill>
                  <a:srgbClr val="000000"/>
                </a:solidFill>
                <a:latin typeface="Times New Roman"/>
              </a:rPr>
              <a:t>11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666880" y="2590920"/>
            <a:ext cx="1131840" cy="2073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Nonvac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1-f</a:t>
            </a:r>
            <a:r>
              <a:rPr b="0" lang="en-US" sz="2400" spc="-1" strike="noStrike" baseline="-25000">
                <a:solidFill>
                  <a:srgbClr val="000000"/>
                </a:solidFill>
                <a:latin typeface="Times New Roman"/>
              </a:rPr>
              <a:t>1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r</a:t>
            </a:r>
            <a:r>
              <a:rPr b="0" lang="en-US" sz="2400" spc="-1" strike="noStrike" baseline="-25000">
                <a:solidFill>
                  <a:srgbClr val="000000"/>
                </a:solidFill>
                <a:latin typeface="Times New Roman"/>
              </a:rPr>
              <a:t>01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 flipV="1">
            <a:off x="2362320" y="1309680"/>
            <a:ext cx="304560" cy="457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2666880" y="1309680"/>
            <a:ext cx="228600" cy="457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2666880" y="1309680"/>
            <a:ext cx="40388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6705720" y="1309680"/>
            <a:ext cx="0" cy="380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3963960" y="1309680"/>
            <a:ext cx="124596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Times New Roman"/>
              </a:rPr>
              <a:t>Overal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1752480" y="4800600"/>
            <a:ext cx="0" cy="457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3352680" y="4800600"/>
            <a:ext cx="0" cy="457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1752480" y="5257800"/>
            <a:ext cx="1600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1905120" y="5195880"/>
            <a:ext cx="114300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Times New Roman"/>
              </a:rPr>
              <a:t>Direc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3505320" y="4689360"/>
            <a:ext cx="464796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3581280" y="4800600"/>
            <a:ext cx="0" cy="457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3581280" y="5257800"/>
            <a:ext cx="2514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7315200" y="4800600"/>
            <a:ext cx="0" cy="1143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1295280" y="5943600"/>
            <a:ext cx="6019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4343400" y="5181480"/>
            <a:ext cx="16765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Times New Roman"/>
              </a:rPr>
              <a:t>Indirec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2438280" y="5867280"/>
            <a:ext cx="5257800" cy="532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Times New Roman"/>
              </a:rPr>
              <a:t>Total 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VEF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= 1- (r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Arial"/>
              </a:rPr>
              <a:t>11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/ r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Arial"/>
              </a:rPr>
              <a:t>02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)</a:t>
            </a:r>
            <a:r>
              <a:rPr b="0" lang="en-US" sz="28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76320" y="838080"/>
            <a:ext cx="2361960" cy="94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Times New Roman"/>
              </a:rPr>
              <a:t>Vaccinated 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Times New Roman"/>
              </a:rPr>
              <a:t>Sub-region: 1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6705720" y="762120"/>
            <a:ext cx="2514600" cy="94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Times New Roman"/>
              </a:rPr>
              <a:t>Unvaccinated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Times New Roman"/>
              </a:rPr>
              <a:t>Sub-region 2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457200" y="0"/>
            <a:ext cx="8229600" cy="838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6095880" y="4800600"/>
            <a:ext cx="0" cy="457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2971800" y="1676520"/>
            <a:ext cx="3276720" cy="405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OVEF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Times New Roman"/>
              </a:rPr>
              <a:t>12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= 1- (r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·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Times New Roman"/>
              </a:rPr>
              <a:t>1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/ r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Arial"/>
              </a:rPr>
              <a:t>·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Times New Roman"/>
              </a:rPr>
              <a:t>2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1371600" y="5530680"/>
            <a:ext cx="2743200" cy="405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DVEF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Times New Roman"/>
              </a:rPr>
              <a:t>1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= 1- (r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Times New Roman"/>
              </a:rPr>
              <a:t>11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/ r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Times New Roman"/>
              </a:rPr>
              <a:t>01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4267080" y="5562720"/>
            <a:ext cx="2895840" cy="405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IVEF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Times New Roman"/>
              </a:rPr>
              <a:t>12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= 1- (r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Times New Roman"/>
              </a:rPr>
              <a:t>01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/ r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Times New Roman"/>
              </a:rPr>
              <a:t>02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1295280" y="4800600"/>
            <a:ext cx="0" cy="1143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5105520" y="1905120"/>
            <a:ext cx="3276360" cy="2971800"/>
          </a:xfrm>
          <a:prstGeom prst="ellipse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6259680" y="2666880"/>
            <a:ext cx="1131840" cy="202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Nonvac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f</a:t>
            </a:r>
            <a:r>
              <a:rPr b="0" lang="en-US" sz="2400" spc="-1" strike="noStrike" baseline="-25000">
                <a:solidFill>
                  <a:srgbClr val="000000"/>
                </a:solidFill>
                <a:latin typeface="Times New Roman"/>
              </a:rPr>
              <a:t>2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 = 0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r</a:t>
            </a:r>
            <a:r>
              <a:rPr b="0" lang="en-US" sz="2400" spc="-1" strike="noStrike" baseline="-25000">
                <a:solidFill>
                  <a:srgbClr val="000000"/>
                </a:solidFill>
                <a:latin typeface="Times New Roman"/>
              </a:rPr>
              <a:t>02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1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1-12T23:43:03Z</dcterms:created>
  <dc:creator>nshenvi</dc:creator>
  <dc:description/>
  <dc:language>en-US</dc:language>
  <cp:lastModifiedBy>longini</cp:lastModifiedBy>
  <dcterms:modified xsi:type="dcterms:W3CDTF">2007-09-25T22:50:18Z</dcterms:modified>
  <cp:revision>406</cp:revision>
  <dc:subject/>
  <dc:title>Slide 1</dc:title>
</cp:coreProperties>
</file>